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A34A71-6D8E-4379-B66B-1806C27288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6521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8760" y="6389640"/>
            <a:ext cx="6521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25F2B9-B4D1-40C3-91BA-48968AF642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8760" y="638964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0640" y="638964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90E8D-3CAA-4769-9D57-787ACD253E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23760" y="284652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28400" y="284652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8760" y="638964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23760" y="638964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28400" y="638964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0EFD9-3C9E-4FC1-9DB0-1A03BB467D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8760" y="2846520"/>
            <a:ext cx="6521400" cy="6783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25"/>
              </a:spcBef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D7AAF-F98D-43D9-8774-2A0B0BC742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6521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77F73-8574-46FE-8D2D-2D193545EB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E9E3A-E19E-4C15-972A-EDF1643404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3E022C-F7E3-4380-B67B-2F1418B904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8760" y="569520"/>
            <a:ext cx="6521400" cy="957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8FC38-261C-40F9-8C8E-53D4DD3522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8760" y="638964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D8163-0102-442C-8DE5-ED4C88ABC3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0640" y="638964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B1005-F560-44DE-84E0-89E6907FE1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8760" y="6389640"/>
            <a:ext cx="6521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30618-4319-418C-AFFF-4839DF2561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8760" y="2846520"/>
            <a:ext cx="6521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900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566640" indent="-18864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94464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1322280" indent="-18864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8760" y="9909000"/>
            <a:ext cx="170172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03080" y="9909000"/>
            <a:ext cx="255276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338440" y="9909000"/>
            <a:ext cx="170172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DDC5501-F48F-4087-9BB3-34A338C52B29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2.jpeg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2.jpeg"/><Relationship Id="rId7" Type="http://schemas.openxmlformats.org/officeDocument/2006/relationships/image" Target="../media/image2.jpeg"/><Relationship Id="rId8" Type="http://schemas.openxmlformats.org/officeDocument/2006/relationships/image" Target="../media/image3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rcRect l="36898" t="48413" r="32698" b="35388"/>
          <a:stretch/>
        </p:blipFill>
        <p:spPr>
          <a:xfrm>
            <a:off x="2581200" y="4294080"/>
            <a:ext cx="2121120" cy="19605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rcRect l="39570" t="40755" r="30179" b="42743"/>
          <a:stretch/>
        </p:blipFill>
        <p:spPr>
          <a:xfrm>
            <a:off x="2581200" y="2448000"/>
            <a:ext cx="2075040" cy="18828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rcRect l="40942" t="0" r="22959" b="81734"/>
          <a:stretch/>
        </p:blipFill>
        <p:spPr>
          <a:xfrm>
            <a:off x="2616120" y="331920"/>
            <a:ext cx="2475000" cy="20844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"/>
          <p:cNvPicPr/>
          <p:nvPr/>
        </p:nvPicPr>
        <p:blipFill>
          <a:blip r:embed="rId4"/>
          <a:srcRect l="5551" t="48413" r="65568" b="35468"/>
          <a:stretch/>
        </p:blipFill>
        <p:spPr>
          <a:xfrm>
            <a:off x="539640" y="4294080"/>
            <a:ext cx="2016360" cy="19512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7" descr=""/>
          <p:cNvPicPr/>
          <p:nvPr/>
        </p:nvPicPr>
        <p:blipFill>
          <a:blip r:embed="rId5"/>
          <a:srcRect l="7018" t="21033" r="60868" b="60919"/>
          <a:stretch/>
        </p:blipFill>
        <p:spPr>
          <a:xfrm>
            <a:off x="520560" y="6283440"/>
            <a:ext cx="2202120" cy="20588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8" descr=""/>
          <p:cNvPicPr/>
          <p:nvPr/>
        </p:nvPicPr>
        <p:blipFill>
          <a:blip r:embed="rId6"/>
          <a:srcRect l="8153" t="0" r="62335" b="81762"/>
          <a:stretch/>
        </p:blipFill>
        <p:spPr>
          <a:xfrm>
            <a:off x="568440" y="325440"/>
            <a:ext cx="2023920" cy="20811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9" descr=""/>
          <p:cNvPicPr/>
          <p:nvPr/>
        </p:nvPicPr>
        <p:blipFill>
          <a:blip r:embed="rId7"/>
          <a:srcRect l="6500" t="40755" r="63489" b="42574"/>
          <a:stretch/>
        </p:blipFill>
        <p:spPr>
          <a:xfrm>
            <a:off x="515880" y="2428920"/>
            <a:ext cx="2059200" cy="1901880"/>
          </a:xfrm>
          <a:prstGeom prst="rect">
            <a:avLst/>
          </a:prstGeom>
          <a:ln w="0">
            <a:noFill/>
          </a:ln>
        </p:spPr>
      </p:pic>
      <p:sp>
        <p:nvSpPr>
          <p:cNvPr id="48" name="TextBox 10"/>
          <p:cNvSpPr/>
          <p:nvPr/>
        </p:nvSpPr>
        <p:spPr>
          <a:xfrm>
            <a:off x="1184760" y="534960"/>
            <a:ext cx="927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broblas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2° Ab onl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3251880" y="534960"/>
            <a:ext cx="92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broblas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1169640" y="6307200"/>
            <a:ext cx="880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FT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2° Ab onl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1023840" y="2463840"/>
            <a:ext cx="1249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FT1 (no IFN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2° Ab onl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3102120" y="2460600"/>
            <a:ext cx="124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FT1 (no IFN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1059840" y="4378320"/>
            <a:ext cx="1066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FT1 + IFN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2° Ab onl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3151440" y="439272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FT1 + IFN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7"/>
          <p:cNvSpPr/>
          <p:nvPr/>
        </p:nvSpPr>
        <p:spPr>
          <a:xfrm flipH="1" rot="16200000">
            <a:off x="167040" y="1319400"/>
            <a:ext cx="554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Coun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1335240" y="832176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FL1-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3370320" y="832176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FL1-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0"/>
          <p:cNvSpPr/>
          <p:nvPr/>
        </p:nvSpPr>
        <p:spPr>
          <a:xfrm flipH="1" rot="16200000">
            <a:off x="167040" y="3272760"/>
            <a:ext cx="554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Coun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1"/>
          <p:cNvSpPr/>
          <p:nvPr/>
        </p:nvSpPr>
        <p:spPr>
          <a:xfrm flipH="1" rot="16200000">
            <a:off x="167040" y="5231880"/>
            <a:ext cx="554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Coun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2"/>
          <p:cNvSpPr/>
          <p:nvPr/>
        </p:nvSpPr>
        <p:spPr>
          <a:xfrm flipH="1" rot="16200000">
            <a:off x="167040" y="7182000"/>
            <a:ext cx="554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Coun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23" descr=""/>
          <p:cNvPicPr/>
          <p:nvPr/>
        </p:nvPicPr>
        <p:blipFill>
          <a:blip r:embed="rId8"/>
          <a:srcRect l="69406" t="3536" r="0" b="30436"/>
          <a:stretch/>
        </p:blipFill>
        <p:spPr>
          <a:xfrm>
            <a:off x="2616120" y="6230880"/>
            <a:ext cx="2097000" cy="2111400"/>
          </a:xfrm>
          <a:prstGeom prst="rect">
            <a:avLst/>
          </a:prstGeom>
          <a:ln w="0">
            <a:noFill/>
          </a:ln>
        </p:spPr>
      </p:pic>
      <p:sp>
        <p:nvSpPr>
          <p:cNvPr id="62" name="TextBox 24"/>
          <p:cNvSpPr/>
          <p:nvPr/>
        </p:nvSpPr>
        <p:spPr>
          <a:xfrm>
            <a:off x="1771200" y="281160"/>
            <a:ext cx="172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3377520" y="6307200"/>
            <a:ext cx="56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FT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07T09:48:38Z</dcterms:created>
  <dc:creator>Hannah Siddle</dc:creator>
  <dc:description/>
  <dc:language>en-US</dc:language>
  <cp:lastModifiedBy>Hannah Siddle</cp:lastModifiedBy>
  <dcterms:modified xsi:type="dcterms:W3CDTF">2020-10-07T09:50:32Z</dcterms:modified>
  <cp:revision>1</cp:revision>
  <dc:subject/>
  <dc:title>PowerPoint Presentation</dc:title>
</cp:coreProperties>
</file>